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0" r:id="rId2"/>
    <p:sldId id="273" r:id="rId3"/>
    <p:sldId id="261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767"/>
    <p:restoredTop sz="96327"/>
  </p:normalViewPr>
  <p:slideViewPr>
    <p:cSldViewPr snapToGrid="0" snapToObjects="1">
      <p:cViewPr varScale="1">
        <p:scale>
          <a:sx n="93" d="100"/>
          <a:sy n="93" d="100"/>
        </p:scale>
        <p:origin x="25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407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475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303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855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080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846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620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776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446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770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417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250A5-FBC1-BA4C-ACC3-208C01C8E95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49914-9B73-624A-BC81-DA3DD47D02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621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4">
            <a:extLst>
              <a:ext uri="{FF2B5EF4-FFF2-40B4-BE49-F238E27FC236}">
                <a16:creationId xmlns:a16="http://schemas.microsoft.com/office/drawing/2014/main" id="{2BAFBE50-D203-92D5-9140-D3D9CDC27948}"/>
              </a:ext>
            </a:extLst>
          </p:cNvPr>
          <p:cNvSpPr txBox="1">
            <a:spLocks/>
          </p:cNvSpPr>
          <p:nvPr/>
        </p:nvSpPr>
        <p:spPr>
          <a:xfrm>
            <a:off x="281460" y="318319"/>
            <a:ext cx="4655328" cy="244682"/>
          </a:xfrm>
          <a:prstGeom prst="rect">
            <a:avLst/>
          </a:prstGeom>
          <a:noFill/>
        </p:spPr>
        <p:txBody>
          <a:bodyPr vert="horz" wrap="square" lIns="91440" tIns="45720" rIns="91440" bIns="45720" rtlCol="0" anchor="ctr">
            <a:spAutoFit/>
          </a:bodyPr>
          <a:lstStyle>
            <a:lvl1pPr algn="l" defTabSz="685797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Aft>
                <a:spcPts val="600"/>
              </a:spcAft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pic>
        <p:nvPicPr>
          <p:cNvPr id="5" name="Content Placeholder 3" descr="Diagram&#10;&#10;Description automatically generated">
            <a:extLst>
              <a:ext uri="{FF2B5EF4-FFF2-40B4-BE49-F238E27FC236}">
                <a16:creationId xmlns:a16="http://schemas.microsoft.com/office/drawing/2014/main" id="{CFCCD32C-9446-5FF0-A0EB-FC796442447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748020"/>
            <a:ext cx="3933648" cy="244407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C88210E-90CB-EB05-A06E-7ADB4796D7FE}"/>
              </a:ext>
            </a:extLst>
          </p:cNvPr>
          <p:cNvSpPr txBox="1"/>
          <p:nvPr/>
        </p:nvSpPr>
        <p:spPr>
          <a:xfrm>
            <a:off x="160811" y="748020"/>
            <a:ext cx="6754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1909417-968E-EB50-861E-D48D574943A5}"/>
              </a:ext>
            </a:extLst>
          </p:cNvPr>
          <p:cNvSpPr txBox="1"/>
          <p:nvPr/>
        </p:nvSpPr>
        <p:spPr>
          <a:xfrm>
            <a:off x="165429" y="3207838"/>
            <a:ext cx="6754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3C4D80F8-71FC-4509-71A6-61003B8B74A2}"/>
              </a:ext>
            </a:extLst>
          </p:cNvPr>
          <p:cNvGrpSpPr/>
          <p:nvPr/>
        </p:nvGrpSpPr>
        <p:grpSpPr>
          <a:xfrm>
            <a:off x="624050" y="3377115"/>
            <a:ext cx="3521785" cy="1488292"/>
            <a:chOff x="1194034" y="4284608"/>
            <a:chExt cx="5397176" cy="2028851"/>
          </a:xfrm>
        </p:grpSpPr>
        <p:pic>
          <p:nvPicPr>
            <p:cNvPr id="15" name="Picture 14" descr="Chart, scatter chart&#10;&#10;Description automatically generated">
              <a:extLst>
                <a:ext uri="{FF2B5EF4-FFF2-40B4-BE49-F238E27FC236}">
                  <a16:creationId xmlns:a16="http://schemas.microsoft.com/office/drawing/2014/main" id="{E26C4480-47C8-90F6-F10A-45F3A2B327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47219" y="4284608"/>
              <a:ext cx="1916747" cy="1766904"/>
            </a:xfrm>
            <a:prstGeom prst="rect">
              <a:avLst/>
            </a:prstGeom>
          </p:spPr>
        </p:pic>
        <p:pic>
          <p:nvPicPr>
            <p:cNvPr id="16" name="Picture 15" descr="Chart, scatter chart&#10;&#10;Description automatically generated">
              <a:extLst>
                <a:ext uri="{FF2B5EF4-FFF2-40B4-BE49-F238E27FC236}">
                  <a16:creationId xmlns:a16="http://schemas.microsoft.com/office/drawing/2014/main" id="{EA03EB55-DB77-CD7B-9474-2CAC6E71D0B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94034" y="4284608"/>
              <a:ext cx="1991293" cy="1686268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2A4ED45-5EA4-BA97-EF67-8C3B5D36EC56}"/>
                </a:ext>
              </a:extLst>
            </p:cNvPr>
            <p:cNvSpPr txBox="1"/>
            <p:nvPr/>
          </p:nvSpPr>
          <p:spPr>
            <a:xfrm>
              <a:off x="1490481" y="5929363"/>
              <a:ext cx="2286381" cy="3566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: 6.0%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BB0D688-2A65-9DD5-2A74-E44A38717E2E}"/>
                </a:ext>
              </a:extLst>
            </p:cNvPr>
            <p:cNvSpPr txBox="1"/>
            <p:nvPr/>
          </p:nvSpPr>
          <p:spPr>
            <a:xfrm>
              <a:off x="4069507" y="5956830"/>
              <a:ext cx="2521703" cy="3566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: 38.6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168178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1">
            <a:extLst>
              <a:ext uri="{FF2B5EF4-FFF2-40B4-BE49-F238E27FC236}">
                <a16:creationId xmlns:a16="http://schemas.microsoft.com/office/drawing/2014/main" id="{3C8F6578-6C18-9E4A-BE1F-F19A1D1251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4454" y="51640"/>
            <a:ext cx="5915025" cy="1715434"/>
          </a:xfrm>
        </p:spPr>
        <p:txBody>
          <a:bodyPr>
            <a:norm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en-US" sz="1100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1626402-66FD-B7E4-64EF-F34645F683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1142" y="1607689"/>
            <a:ext cx="2095973" cy="291271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194D07C-D5EC-A96B-8492-4E785A8C98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21966" y="1499714"/>
            <a:ext cx="2128567" cy="30539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108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>
            <a:extLst>
              <a:ext uri="{FF2B5EF4-FFF2-40B4-BE49-F238E27FC236}">
                <a16:creationId xmlns:a16="http://schemas.microsoft.com/office/drawing/2014/main" id="{D416ABF6-5EBF-F540-A030-0B4F3D4D0D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06988"/>
            <a:ext cx="5915025" cy="1715434"/>
          </a:xfrm>
        </p:spPr>
        <p:txBody>
          <a:bodyPr>
            <a:norm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en-US" sz="1100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388A12B-D8FF-0C6C-B3C8-F6A6111BAE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7696" y="1785074"/>
            <a:ext cx="2413000" cy="20066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44AF0A9-A67B-B2B2-AECA-6C793002C2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5096" y="1785074"/>
            <a:ext cx="2400300" cy="20193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C06E3EC-C417-78D7-7F6C-4995948BDA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7888" y="1785074"/>
            <a:ext cx="2400300" cy="200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4616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9</Words>
  <Application>Microsoft Macintosh PowerPoint</Application>
  <PresentationFormat>Letter Paper (8.5x11 in)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Supplementary Figure 2</vt:lpstr>
      <vt:lpstr>Supplementary Figure 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nna Labere</dc:creator>
  <cp:lastModifiedBy>Brenna Labere</cp:lastModifiedBy>
  <cp:revision>7</cp:revision>
  <dcterms:created xsi:type="dcterms:W3CDTF">2022-09-21T20:51:29Z</dcterms:created>
  <dcterms:modified xsi:type="dcterms:W3CDTF">2023-05-25T18:29:16Z</dcterms:modified>
</cp:coreProperties>
</file>